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604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955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448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3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912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393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67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637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329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586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32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97364-710E-BF49-97E3-764BFF521F7E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B5552-FA8A-3C4F-B2BC-65FAB4D5D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8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BA0365-9902-384E-87B2-5C03F3E3D469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22281" y="896719"/>
            <a:ext cx="3829298" cy="601746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BAD6021-635B-D547-909F-6F9BF7BFCB87}"/>
              </a:ext>
            </a:extLst>
          </p:cNvPr>
          <p:cNvSpPr txBox="1"/>
          <p:nvPr/>
        </p:nvSpPr>
        <p:spPr>
          <a:xfrm>
            <a:off x="2142287" y="8696122"/>
            <a:ext cx="212750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3</a:t>
            </a:r>
          </a:p>
        </p:txBody>
      </p:sp>
    </p:spTree>
    <p:extLst>
      <p:ext uri="{BB962C8B-B14F-4D97-AF65-F5344CB8AC3E}">
        <p14:creationId xmlns:p14="http://schemas.microsoft.com/office/powerpoint/2010/main" val="2370511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286F825-E05A-A7A6-F4EE-A62FB2B19D9E}"/>
              </a:ext>
            </a:extLst>
          </p:cNvPr>
          <p:cNvSpPr txBox="1"/>
          <p:nvPr/>
        </p:nvSpPr>
        <p:spPr>
          <a:xfrm>
            <a:off x="215348" y="368541"/>
            <a:ext cx="64273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3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GSEA analyses of vitamin 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transcriptional response in AA patients associated within immuno-modulatory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PC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relevant pathways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2395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4</Words>
  <Application>Microsoft Macintosh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20:03:15Z</dcterms:created>
  <dcterms:modified xsi:type="dcterms:W3CDTF">2023-02-21T20:04:10Z</dcterms:modified>
</cp:coreProperties>
</file>